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17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CTNNB1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2z6g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2z6g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42910" y="285728"/>
            <a:ext cx="3092543" cy="25717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43533" y="142853"/>
            <a:ext cx="3543309" cy="303018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10244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42910" y="3286124"/>
            <a:ext cx="3071834" cy="26432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45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86380" y="3286124"/>
            <a:ext cx="3500462" cy="2694109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61</cp:revision>
  <dcterms:created xsi:type="dcterms:W3CDTF">2018-05-10T07:33:24Z</dcterms:created>
  <dcterms:modified xsi:type="dcterms:W3CDTF">2018-05-29T06:56:25Z</dcterms:modified>
</cp:coreProperties>
</file>